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84" d="100"/>
          <a:sy n="84" d="100"/>
        </p:scale>
        <p:origin x="614" y="31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6/30/2023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6/30/20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6/30/2023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6/30/20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6/30/20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6/30/20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6/30/20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6/30/2023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6/30/2023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6/30/2023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6/30/2023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6/30/2023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6/30/2023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6/30/2023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38800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24277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AU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rdiac metastases from neuroendocrine neoplasms: Complementary role of SSTR PET/CT and Cardiac MRI</a:t>
            </a:r>
            <a:endParaRPr lang="en-AU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77000" cy="12192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>
              <a:spcAft>
                <a:spcPts val="800"/>
              </a:spcAft>
            </a:pPr>
            <a:r>
              <a:rPr lang="en-AU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vyn G. Arnfield</a:t>
            </a:r>
            <a:r>
              <a:rPr lang="en-AU" sz="10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,2</a:t>
            </a:r>
            <a:r>
              <a:rPr lang="en-AU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Laura Tam</a:t>
            </a:r>
            <a:r>
              <a:rPr lang="en-AU" sz="10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,2</a:t>
            </a:r>
            <a:r>
              <a:rPr lang="en-AU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David A. Pattison</a:t>
            </a:r>
            <a:r>
              <a:rPr lang="en-AU" sz="10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,2</a:t>
            </a:r>
            <a:r>
              <a:rPr lang="en-AU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John Younger</a:t>
            </a:r>
            <a:r>
              <a:rPr lang="en-AU" sz="10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,2</a:t>
            </a:r>
            <a:r>
              <a:rPr lang="en-AU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Venkata Avinash Chikatamarla</a:t>
            </a:r>
            <a:r>
              <a:rPr lang="en-AU" sz="10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,2</a:t>
            </a:r>
            <a:r>
              <a:rPr lang="en-AU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David Wyld</a:t>
            </a:r>
            <a:r>
              <a:rPr lang="en-AU" sz="10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,2</a:t>
            </a:r>
            <a:r>
              <a:rPr lang="en-AU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Matthew Burge</a:t>
            </a:r>
            <a:r>
              <a:rPr lang="en-AU" sz="10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,2</a:t>
            </a:r>
            <a:r>
              <a:rPr lang="en-AU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Louise McCormack</a:t>
            </a:r>
            <a:r>
              <a:rPr lang="en-AU" sz="10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,2</a:t>
            </a:r>
            <a:r>
              <a:rPr lang="en-AU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Rahul Ladwa</a:t>
            </a:r>
            <a:r>
              <a:rPr lang="en-AU" sz="10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,2</a:t>
            </a:r>
            <a:r>
              <a:rPr lang="en-AU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Stuart Ramsay</a:t>
            </a:r>
            <a:r>
              <a:rPr lang="en-AU" sz="10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,2</a:t>
            </a:r>
          </a:p>
          <a:p>
            <a:pPr marL="342900" lvl="0">
              <a:buFont typeface="+mj-lt"/>
              <a:buAutoNum type="arabicPeriod"/>
            </a:pPr>
            <a:r>
              <a:rPr lang="en-AU" sz="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partment of Nuclear Medicine &amp; Specialised PET Services, Royal Brisbane and Women’s Hospital, Brisbane, Australia</a:t>
            </a:r>
            <a:endParaRPr lang="en-AU" sz="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lvl="0">
              <a:buFont typeface="+mj-lt"/>
              <a:buAutoNum type="arabicPeriod"/>
            </a:pPr>
            <a:r>
              <a:rPr lang="en-AU" sz="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aculty of Medicine, University of Queensland, Brisbane, Australia</a:t>
            </a:r>
            <a:endParaRPr lang="en-AU" sz="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lvl="0">
              <a:buFont typeface="+mj-lt"/>
              <a:buAutoNum type="arabicPeriod"/>
            </a:pPr>
            <a:r>
              <a:rPr lang="en-AU" sz="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partment of Medical Oncology, Princess Alexandra Hospital, Woolloongabba, Australia</a:t>
            </a:r>
            <a:endParaRPr lang="en-AU" sz="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lvl="0">
              <a:buFont typeface="+mj-lt"/>
              <a:buAutoNum type="arabicPeriod"/>
            </a:pPr>
            <a:r>
              <a:rPr lang="en-AU" sz="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partment of Cardiology, Royal Brisbane and Women’s Hospital, Brisbane, Australia</a:t>
            </a:r>
            <a:endParaRPr lang="en-AU" sz="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lvl="0">
              <a:spcAft>
                <a:spcPts val="800"/>
              </a:spcAft>
              <a:buFont typeface="+mj-lt"/>
              <a:buAutoNum type="arabicPeriod"/>
            </a:pPr>
            <a:r>
              <a:rPr lang="en-AU" sz="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partment of Medical Oncology, Royal Brisbane and Women’s Hospital, Brisbane, Australia</a:t>
            </a:r>
            <a:endParaRPr lang="en-AU" sz="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800"/>
              </a:spcAft>
            </a:pPr>
            <a:endParaRPr lang="en-AU" sz="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 descr="A person smiling for the camera&#10;&#10;Description automatically generated with low confidence">
            <a:extLst>
              <a:ext uri="{FF2B5EF4-FFF2-40B4-BE49-F238E27FC236}">
                <a16:creationId xmlns:a16="http://schemas.microsoft.com/office/drawing/2014/main" id="{6BA773FD-94F8-2F02-5C6D-D2570A10F4F0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3267" y="3879705"/>
            <a:ext cx="1143220" cy="15240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A0145220-EA07-38DA-A69A-38D4B718FB7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715000" y="4321290"/>
            <a:ext cx="1828800" cy="684494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/>
              <a:t>1- </a:t>
            </a:r>
            <a:r>
              <a:rPr lang="en-AU" sz="2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ardiac metastases from neuroendocrine neoplasms (NENs) are being detected with increasing frequency.</a:t>
            </a:r>
            <a:endParaRPr lang="en-US" altLang="en-US" sz="2800" dirty="0"/>
          </a:p>
          <a:p>
            <a:pPr marL="0" indent="0">
              <a:buNone/>
            </a:pPr>
            <a:r>
              <a:rPr lang="en-US" altLang="en-US" sz="2800" dirty="0"/>
              <a:t>2- </a:t>
            </a:r>
            <a:r>
              <a:rPr lang="en-AU" altLang="en-US" sz="2800" dirty="0">
                <a:latin typeface="Times New Roman" panose="02020603050405020304" pitchFamily="18" charset="0"/>
                <a:ea typeface="Calibri" panose="020F0502020204030204" pitchFamily="34" charset="0"/>
              </a:rPr>
              <a:t>T</a:t>
            </a:r>
            <a:r>
              <a:rPr lang="en-AU" sz="2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he optimal imaging strategy remains unclear. </a:t>
            </a:r>
          </a:p>
          <a:p>
            <a:pPr marL="0" indent="0">
              <a:buNone/>
            </a:pPr>
            <a:r>
              <a:rPr lang="en-US" altLang="en-US" sz="2800" dirty="0"/>
              <a:t>3- </a:t>
            </a:r>
            <a:r>
              <a:rPr lang="en-AU" altLang="en-US" sz="2800" dirty="0">
                <a:latin typeface="Times New Roman" panose="02020603050405020304" pitchFamily="18" charset="0"/>
                <a:ea typeface="Calibri" panose="020F0502020204030204" pitchFamily="34" charset="0"/>
              </a:rPr>
              <a:t>Limited data suggests that Peptide Receptor Radionuclide Therapy (PRRT) can be safely delivered in patients with NEN cardiac metastases.</a:t>
            </a: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type:</a:t>
            </a:r>
            <a:endParaRPr lang="en-US" altLang="en-US" sz="2400" dirty="0"/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Retrospective case series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subjects: </a:t>
            </a:r>
            <a:r>
              <a:rPr lang="en-AU" sz="2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19 patients with NEN cardiac metastases</a:t>
            </a:r>
            <a:endParaRPr lang="en-US" altLang="en-US" sz="28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Primary end points: number of NEN cardiac metastases identified by SSTR PET/CT and Cardiac MRI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econdary end points: adverse events from PRRT in patients with NEN cardiac metastases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3" name="Picture 2" descr="A close-up of a scan of a person's body&#10;&#10;Description automatically generated with low confidence">
            <a:extLst>
              <a:ext uri="{FF2B5EF4-FFF2-40B4-BE49-F238E27FC236}">
                <a16:creationId xmlns:a16="http://schemas.microsoft.com/office/drawing/2014/main" id="{5CC81DD3-9753-341D-4242-AA14A404055F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3400" y="1524000"/>
            <a:ext cx="8077200" cy="40386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3FA62C28-A618-72A4-36C7-66A7801CE30E}"/>
              </a:ext>
            </a:extLst>
          </p:cNvPr>
          <p:cNvSpPr txBox="1"/>
          <p:nvPr/>
        </p:nvSpPr>
        <p:spPr>
          <a:xfrm>
            <a:off x="533400" y="5562600"/>
            <a:ext cx="8229600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kern="100" dirty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a) [68Ga]Ga-DOTATATE PET/CT images in a patient with metastatic small bowel NEN demonstrating multiple avid cardiac metastases involving the right ventricular free wall. b) CMR four chamber images (T2-weighted, T2-weighted fat saturated, and late gadolinium enhancement sequences) do not demonstrate these metastases. No lesions were identifiable on CMR in this case.</a:t>
            </a:r>
          </a:p>
          <a:p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3" name="Picture 2" descr="A picture containing x-ray film, art&#10;&#10;Description automatically generated">
            <a:extLst>
              <a:ext uri="{FF2B5EF4-FFF2-40B4-BE49-F238E27FC236}">
                <a16:creationId xmlns:a16="http://schemas.microsoft.com/office/drawing/2014/main" id="{D2F5FE4F-030A-AFA0-253D-F408373368A7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1099" y="1532149"/>
            <a:ext cx="7915701" cy="395785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5E4326FF-A678-EA3B-4F7A-173490767F5E}"/>
              </a:ext>
            </a:extLst>
          </p:cNvPr>
          <p:cNvSpPr txBox="1"/>
          <p:nvPr/>
        </p:nvSpPr>
        <p:spPr>
          <a:xfrm>
            <a:off x="609600" y="5486400"/>
            <a:ext cx="8153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dirty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a) [68Ga]Ga-DOTATATE PET/CT images in a patient with metastatic small bowel NEN demonstrating an intensely avid metastasis in the apical septal left ventricle (segment 14). b) SPECT/CT images performed 24 hours following treatment with 8.3Gbq (224mCi) of intravenous [177Lu]Lu-DOTATATE demonstrate high radiopharmaceutical retention within this metastasis. No cardiac complication occurred.</a:t>
            </a:r>
            <a:endParaRPr lang="en-AU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/>
              <a:t>1- </a:t>
            </a:r>
            <a:r>
              <a:rPr lang="en-AU" sz="2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STR PET/CT and </a:t>
            </a:r>
            <a:r>
              <a:rPr lang="en-AU" sz="2800" dirty="0">
                <a:latin typeface="Times New Roman" panose="02020603050405020304" pitchFamily="18" charset="0"/>
                <a:ea typeface="Calibri" panose="020F0502020204030204" pitchFamily="34" charset="0"/>
              </a:rPr>
              <a:t>c</a:t>
            </a:r>
            <a:r>
              <a:rPr lang="en-AU" sz="2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rdiac MRI are complementary investigations in the imaging of NEN cardiac metastases.</a:t>
            </a:r>
            <a:endParaRPr lang="en-US" altLang="en-US" sz="2800" dirty="0"/>
          </a:p>
          <a:p>
            <a:pPr marL="0" indent="0">
              <a:buNone/>
            </a:pPr>
            <a:r>
              <a:rPr lang="en-US" altLang="en-US" sz="2800" dirty="0"/>
              <a:t>2- </a:t>
            </a:r>
            <a:r>
              <a:rPr lang="en-AU" sz="2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STR</a:t>
            </a:r>
            <a:r>
              <a:rPr lang="en-AU" sz="2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PET/CT appears to have higher sensitivity for detection, while cardiac MRI provides more accurate lesion characterisation</a:t>
            </a:r>
            <a:endParaRPr lang="en-US" altLang="en-US" sz="2800" dirty="0"/>
          </a:p>
          <a:p>
            <a:pPr marL="0" indent="0">
              <a:buNone/>
            </a:pPr>
            <a:r>
              <a:rPr lang="en-US" altLang="en-US" sz="2800" dirty="0"/>
              <a:t>3- </a:t>
            </a:r>
            <a:r>
              <a:rPr lang="en-AU" sz="2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RRT can be administered safely to patients with NEN cardiac metastases in a multidisciplinary setting without the need for dose reduction</a:t>
            </a:r>
            <a:endParaRPr lang="en-US" altLang="en-US" sz="2800" dirty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1</TotalTime>
  <Words>535</Words>
  <Application>Microsoft Office PowerPoint</Application>
  <PresentationFormat>On-screen Show (4:3)</PresentationFormat>
  <Paragraphs>38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3</vt:i4>
      </vt:variant>
      <vt:variant>
        <vt:lpstr>Slide Titles</vt:lpstr>
      </vt:variant>
      <vt:variant>
        <vt:i4>6</vt:i4>
      </vt:variant>
    </vt:vector>
  </HeadingPairs>
  <TitlesOfParts>
    <vt:vector size="14" baseType="lpstr"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Cardiac metastases from neuroendocrine neoplasms: Complementary role of SSTR PET/CT and Cardiac MRI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Evyn Arnfield</cp:lastModifiedBy>
  <cp:revision>98</cp:revision>
  <dcterms:created xsi:type="dcterms:W3CDTF">2011-04-18T21:44:13Z</dcterms:created>
  <dcterms:modified xsi:type="dcterms:W3CDTF">2023-06-29T23:26:18Z</dcterms:modified>
</cp:coreProperties>
</file>